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62" r:id="rId4"/>
    <p:sldId id="258" r:id="rId5"/>
    <p:sldId id="263" r:id="rId6"/>
    <p:sldId id="259" r:id="rId7"/>
    <p:sldId id="260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23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6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919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016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490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684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90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167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48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198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026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567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37391-60BC-4366-BEFB-0F329151CB2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D3ABE-8231-4EC8-B908-4B076D881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7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8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61041" t="50871" r="3759" b="41790"/>
          <a:stretch/>
        </p:blipFill>
        <p:spPr>
          <a:xfrm>
            <a:off x="6047975" y="6149881"/>
            <a:ext cx="3279090" cy="25448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52397" t="46364" r="12616" b="36929"/>
          <a:stretch/>
        </p:blipFill>
        <p:spPr>
          <a:xfrm>
            <a:off x="6003494" y="3204390"/>
            <a:ext cx="3210346" cy="32780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2349560" y="1072661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4175" y="1594237"/>
            <a:ext cx="1842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Tx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Time (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15358" y="1575532"/>
            <a:ext cx="29129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493725" y="2082654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cxnSp>
        <p:nvCxnSpPr>
          <p:cNvPr id="15" name="Straight Connector 14"/>
          <p:cNvCxnSpPr>
            <a:cxnSpLocks/>
          </p:cNvCxnSpPr>
          <p:nvPr/>
        </p:nvCxnSpPr>
        <p:spPr>
          <a:xfrm>
            <a:off x="2636987" y="1561078"/>
            <a:ext cx="318895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757144" y="2608844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894698" y="1095663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 MG-13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181865" y="1575533"/>
            <a:ext cx="29129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</a:t>
            </a:r>
          </a:p>
        </p:txBody>
      </p:sp>
      <p:cxnSp>
        <p:nvCxnSpPr>
          <p:cNvPr id="30" name="Straight Connector 29"/>
          <p:cNvCxnSpPr>
            <a:cxnSpLocks/>
          </p:cNvCxnSpPr>
          <p:nvPr/>
        </p:nvCxnSpPr>
        <p:spPr>
          <a:xfrm>
            <a:off x="6003494" y="1561079"/>
            <a:ext cx="328307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396066" y="3949650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nM dBET6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824170" y="4451833"/>
            <a:ext cx="29129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</a:t>
            </a:r>
          </a:p>
        </p:txBody>
      </p:sp>
      <p:cxnSp>
        <p:nvCxnSpPr>
          <p:cNvPr id="33" name="Straight Connector 32"/>
          <p:cNvCxnSpPr>
            <a:cxnSpLocks/>
          </p:cNvCxnSpPr>
          <p:nvPr/>
        </p:nvCxnSpPr>
        <p:spPr>
          <a:xfrm>
            <a:off x="2645799" y="4437379"/>
            <a:ext cx="32643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894698" y="3975714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G-132, dBET6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235157" y="4451833"/>
            <a:ext cx="3082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 .75     1     3      5</a:t>
            </a:r>
          </a:p>
        </p:txBody>
      </p:sp>
      <p:cxnSp>
        <p:nvCxnSpPr>
          <p:cNvPr id="36" name="Straight Connector 35"/>
          <p:cNvCxnSpPr>
            <a:cxnSpLocks/>
          </p:cNvCxnSpPr>
          <p:nvPr/>
        </p:nvCxnSpPr>
        <p:spPr>
          <a:xfrm>
            <a:off x="6056786" y="4437379"/>
            <a:ext cx="327909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670530" y="4457348"/>
            <a:ext cx="1842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Tx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Time (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370080" y="4945765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630781" y="6135557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-124762" y="111357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CI-AML2 Cell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01A96DD-E5B0-624D-8D0B-0402FD0DD09E}"/>
              </a:ext>
            </a:extLst>
          </p:cNvPr>
          <p:cNvSpPr txBox="1"/>
          <p:nvPr/>
        </p:nvSpPr>
        <p:spPr>
          <a:xfrm>
            <a:off x="1746450" y="3140679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9884E5-9F76-A947-B6CE-D61798863D93}"/>
              </a:ext>
            </a:extLst>
          </p:cNvPr>
          <p:cNvSpPr txBox="1"/>
          <p:nvPr/>
        </p:nvSpPr>
        <p:spPr>
          <a:xfrm>
            <a:off x="1757144" y="5628587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D33CABC-C013-D046-B903-2DDA0DA4AF7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" r="58638" b="10959"/>
          <a:stretch/>
        </p:blipFill>
        <p:spPr>
          <a:xfrm>
            <a:off x="2631057" y="5626698"/>
            <a:ext cx="3279090" cy="40749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9C9C2A8-DEAB-A24E-916B-70BB60F3E36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0984"/>
          <a:stretch/>
        </p:blipFill>
        <p:spPr>
          <a:xfrm>
            <a:off x="2615599" y="2629948"/>
            <a:ext cx="3210346" cy="46804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FC107A8-BD04-6F4D-B213-18657B1C8E5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796" t="12687" r="4026" b="23797"/>
          <a:stretch/>
        </p:blipFill>
        <p:spPr>
          <a:xfrm>
            <a:off x="6056786" y="4983987"/>
            <a:ext cx="3279090" cy="53734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68D579A-F354-3C4E-80AB-BA8F8F75A6E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863" r="60076" b="19691"/>
          <a:stretch/>
        </p:blipFill>
        <p:spPr>
          <a:xfrm>
            <a:off x="2615599" y="2051650"/>
            <a:ext cx="3210346" cy="46624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ECDCC70D-92CE-FD44-8E60-941E2C4835F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6180" r="57955" b="20305"/>
          <a:stretch/>
        </p:blipFill>
        <p:spPr>
          <a:xfrm>
            <a:off x="2631056" y="4976600"/>
            <a:ext cx="3279090" cy="52625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220208A7-4AAA-874B-862E-5DB075F9B58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3470" t="15271" r="8013" b="14930"/>
          <a:stretch/>
        </p:blipFill>
        <p:spPr>
          <a:xfrm>
            <a:off x="6004315" y="2051650"/>
            <a:ext cx="3210346" cy="45930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76522D4-7CFB-B443-A1FF-CB0BCB6E857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4508" t="1" r="4130" b="10959"/>
          <a:stretch/>
        </p:blipFill>
        <p:spPr>
          <a:xfrm>
            <a:off x="6047975" y="5631859"/>
            <a:ext cx="3279090" cy="40749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917A7A06-CEDD-5E46-A020-1A29743547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360" t="50871" r="51440" b="41790"/>
          <a:stretch/>
        </p:blipFill>
        <p:spPr>
          <a:xfrm>
            <a:off x="2615599" y="6158036"/>
            <a:ext cx="3294547" cy="25568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6340F937-55A2-8743-81E1-30CECDBE662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2558" r="7684"/>
          <a:stretch/>
        </p:blipFill>
        <p:spPr>
          <a:xfrm>
            <a:off x="6003494" y="2626131"/>
            <a:ext cx="3210346" cy="45930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A9FC2260-458C-7944-A70E-1D5969DC06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51" t="46364" r="59636" b="36929"/>
          <a:stretch/>
        </p:blipFill>
        <p:spPr>
          <a:xfrm>
            <a:off x="2615599" y="3204389"/>
            <a:ext cx="3210345" cy="33424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619626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3360" t="50871" r="375" b="41790"/>
          <a:stretch/>
        </p:blipFill>
        <p:spPr>
          <a:xfrm>
            <a:off x="2617481" y="6221567"/>
            <a:ext cx="8035956" cy="25448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2000"/>
                    </a14:imgEffect>
                  </a14:imgLayer>
                </a14:imgProps>
              </a:ext>
            </a:extLst>
          </a:blip>
          <a:srcRect l="12821" t="38995" r="787" b="47597"/>
          <a:stretch/>
        </p:blipFill>
        <p:spPr>
          <a:xfrm>
            <a:off x="2631057" y="4999592"/>
            <a:ext cx="8031191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6051" t="46364" r="5991" b="36929"/>
          <a:stretch/>
        </p:blipFill>
        <p:spPr>
          <a:xfrm>
            <a:off x="2636987" y="3241790"/>
            <a:ext cx="8070908" cy="32780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2342" t="37619" r="2300" b="37997"/>
          <a:stretch/>
        </p:blipFill>
        <p:spPr>
          <a:xfrm>
            <a:off x="2636987" y="2162523"/>
            <a:ext cx="8070908" cy="30192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2636988" y="1084960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4175" y="1594237"/>
            <a:ext cx="1842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Tx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Time (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15358" y="1575532"/>
            <a:ext cx="35942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      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493725" y="2082654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2636987" y="1561078"/>
            <a:ext cx="37638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757144" y="2608844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89625" y="1084960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 MG-13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067995" y="1575532"/>
            <a:ext cx="35942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      7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6889624" y="1561078"/>
            <a:ext cx="37638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645800" y="3961261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nM dBET6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824170" y="4451833"/>
            <a:ext cx="35942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      7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2645799" y="4437379"/>
            <a:ext cx="37638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7067995" y="3932036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G-132, dBET6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246365" y="4422608"/>
            <a:ext cx="35942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0    .75    1     3      5      7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7067994" y="4408154"/>
            <a:ext cx="37638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670530" y="4457348"/>
            <a:ext cx="1842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Tx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Time (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370080" y="4945765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630781" y="6135557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45" name="Straight Arrow Connector 44"/>
          <p:cNvCxnSpPr/>
          <p:nvPr/>
        </p:nvCxnSpPr>
        <p:spPr>
          <a:xfrm flipV="1">
            <a:off x="2987794" y="4802967"/>
            <a:ext cx="0" cy="1427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-124762" y="111357"/>
            <a:ext cx="3763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CI-AML2 Cell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01A96DD-E5B0-624D-8D0B-0402FD0DD09E}"/>
              </a:ext>
            </a:extLst>
          </p:cNvPr>
          <p:cNvSpPr txBox="1"/>
          <p:nvPr/>
        </p:nvSpPr>
        <p:spPr>
          <a:xfrm>
            <a:off x="1746450" y="3140679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9884E5-9F76-A947-B6CE-D61798863D93}"/>
              </a:ext>
            </a:extLst>
          </p:cNvPr>
          <p:cNvSpPr txBox="1"/>
          <p:nvPr/>
        </p:nvSpPr>
        <p:spPr>
          <a:xfrm>
            <a:off x="1757144" y="5628587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D33CABC-C013-D046-B903-2DDA0DA4AF7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" r="1444" b="10959"/>
          <a:stretch/>
        </p:blipFill>
        <p:spPr>
          <a:xfrm>
            <a:off x="2631056" y="5626698"/>
            <a:ext cx="8022381" cy="4184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9C9C2A8-DEAB-A24E-916B-70BB60F3E36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33183" y="2626130"/>
            <a:ext cx="8074711" cy="45930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015220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E29F0232-87A4-49E3-A960-2B7FB9678659}"/>
              </a:ext>
            </a:extLst>
          </p:cNvPr>
          <p:cNvSpPr/>
          <p:nvPr/>
        </p:nvSpPr>
        <p:spPr>
          <a:xfrm>
            <a:off x="330587" y="475008"/>
            <a:ext cx="28745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BET6, MG132_dBET6, Act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8639FA7-D9FE-4AF5-8D34-2222701DF4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262" y="1676400"/>
            <a:ext cx="9515475" cy="350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1915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877016BA-F058-4C97-AC56-50CEBF75FB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3987" y="1271587"/>
            <a:ext cx="9344025" cy="4314825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B656010F-488A-4D8D-81C1-C63CD6DA062C}"/>
              </a:ext>
            </a:extLst>
          </p:cNvPr>
          <p:cNvSpPr/>
          <p:nvPr/>
        </p:nvSpPr>
        <p:spPr>
          <a:xfrm>
            <a:off x="219415" y="344116"/>
            <a:ext cx="30155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BET6, MG132_dBET6, gH2AX</a:t>
            </a:r>
          </a:p>
        </p:txBody>
      </p:sp>
    </p:spTree>
    <p:extLst>
      <p:ext uri="{BB962C8B-B14F-4D97-AF65-F5344CB8AC3E}">
        <p14:creationId xmlns:p14="http://schemas.microsoft.com/office/powerpoint/2010/main" val="3313718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B34F67E-3D2C-4F09-BD3A-70A241D702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0125" y="1662112"/>
            <a:ext cx="10191750" cy="353377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03752B3-8055-48C1-BFA4-754A78060F12}"/>
              </a:ext>
            </a:extLst>
          </p:cNvPr>
          <p:cNvSpPr/>
          <p:nvPr/>
        </p:nvSpPr>
        <p:spPr>
          <a:xfrm>
            <a:off x="513077" y="422757"/>
            <a:ext cx="2956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BET6, MG132_dBET6, c-</a:t>
            </a:r>
            <a:r>
              <a:rPr lang="en-US" dirty="0" err="1"/>
              <a:t>My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23207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01FB9B-304D-4F65-B88B-045D0FF99B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5425" y="1385887"/>
            <a:ext cx="9201150" cy="40862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5F3F479-51D7-4EE9-A503-963752AB3F16}"/>
              </a:ext>
            </a:extLst>
          </p:cNvPr>
          <p:cNvSpPr/>
          <p:nvPr/>
        </p:nvSpPr>
        <p:spPr>
          <a:xfrm>
            <a:off x="270235" y="344116"/>
            <a:ext cx="21750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MSO, MG132, Actin</a:t>
            </a:r>
          </a:p>
        </p:txBody>
      </p:sp>
    </p:spTree>
    <p:extLst>
      <p:ext uri="{BB962C8B-B14F-4D97-AF65-F5344CB8AC3E}">
        <p14:creationId xmlns:p14="http://schemas.microsoft.com/office/powerpoint/2010/main" val="31039223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C29EEE9-AF26-4478-8AD2-A65F35FED6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652587"/>
            <a:ext cx="9144000" cy="35528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EC73FA5-A116-4570-860B-A8BD5E0AB922}"/>
              </a:ext>
            </a:extLst>
          </p:cNvPr>
          <p:cNvSpPr/>
          <p:nvPr/>
        </p:nvSpPr>
        <p:spPr>
          <a:xfrm>
            <a:off x="365958" y="452312"/>
            <a:ext cx="23160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MSO, MG132, gH2AX</a:t>
            </a:r>
          </a:p>
        </p:txBody>
      </p:sp>
    </p:spTree>
    <p:extLst>
      <p:ext uri="{BB962C8B-B14F-4D97-AF65-F5344CB8AC3E}">
        <p14:creationId xmlns:p14="http://schemas.microsoft.com/office/powerpoint/2010/main" val="40122174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A085B86-4795-47E0-B4F2-B19D0234BE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4612" y="2085975"/>
            <a:ext cx="6962775" cy="268605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E930CF7-F98D-412D-8AE2-0E09854FF5CC}"/>
              </a:ext>
            </a:extLst>
          </p:cNvPr>
          <p:cNvSpPr/>
          <p:nvPr/>
        </p:nvSpPr>
        <p:spPr>
          <a:xfrm>
            <a:off x="166688" y="544677"/>
            <a:ext cx="22570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DMSO, MG132, c-</a:t>
            </a:r>
            <a:r>
              <a:rPr lang="en-US" dirty="0" err="1"/>
              <a:t>My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3875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6</TotalTime>
  <Words>148</Words>
  <Application>Microsoft Office PowerPoint</Application>
  <PresentationFormat>Widescreen</PresentationFormat>
  <Paragraphs>4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uke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10</cp:revision>
  <dcterms:created xsi:type="dcterms:W3CDTF">2018-05-15T21:10:19Z</dcterms:created>
  <dcterms:modified xsi:type="dcterms:W3CDTF">2020-04-13T03:25:30Z</dcterms:modified>
</cp:coreProperties>
</file>